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6.png" ContentType="image/png"/>
  <Override PartName="/ppt/media/image7.jpeg" ContentType="image/jpeg"/>
  <Override PartName="/ppt/media/image11.png" ContentType="image/png"/>
  <Override PartName="/ppt/media/image8.png" ContentType="image/png"/>
  <Override PartName="/ppt/media/image10.jpeg" ContentType="image/jpeg"/>
  <Override PartName="/ppt/media/image12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E8D54-9AA2-4DD0-9470-0ACF857E499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EE7EA9-81D8-44ED-A3F0-C78154AF65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7C555-F8E9-4388-85C8-5F0BA60D14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4C42B-4836-41A5-95D1-93F0113E62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FF5A3-92DE-4DFE-952A-2637A351B2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F78E97-6A5F-4F67-9917-7DA42DDB70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AC416-606D-4B95-9E05-579EA72BB5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C6662-A3E7-41E1-B967-9B97FDB2EF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61426-3010-45F8-8AAB-D55E00BDB26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D36CB7-0E0C-4015-917F-1AFEDC7508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1EED2C-05DE-459F-84F6-F9C8323282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C58850-FBB0-4FDA-8DA4-D9992CA9D2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717D570-9C02-4ADE-919B-990D6F14415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jpeg"/><Relationship Id="rId2" Type="http://schemas.openxmlformats.org/officeDocument/2006/relationships/image" Target="../media/image8.png"/><Relationship Id="rId3" Type="http://schemas.openxmlformats.org/officeDocument/2006/relationships/slideLayout" Target="../slideLayouts/slideLayout3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jpeg"/><Relationship Id="rId2" Type="http://schemas.openxmlformats.org/officeDocument/2006/relationships/image" Target="../media/image10.jpeg"/><Relationship Id="rId3" Type="http://schemas.openxmlformats.org/officeDocument/2006/relationships/slideLayout" Target="../slideLayouts/slideLayout2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slideLayout" Target="../slideLayouts/slideLayout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84680" y="115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263520" y="2997360"/>
            <a:ext cx="17046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 =0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19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723280" y="2997360"/>
            <a:ext cx="19184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</a:t>
            </a:r>
            <a:r>
              <a:rPr b="0" lang="es-E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=0.013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986920" y="2997360"/>
            <a:ext cx="1875240" cy="82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 =0.00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30</a:t>
            </a:r>
            <a:r>
              <a:rPr b="1" lang="es-ES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62440" y="6178680"/>
            <a:ext cx="1875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 =0.03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723640" y="6178680"/>
            <a:ext cx="18752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 =0.07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1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986920" y="6178680"/>
            <a:ext cx="1918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Nominal p-value = 0.0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FDR q-value= 0.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324000" y="476280"/>
            <a:ext cx="2447640" cy="244800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2"/>
          <a:stretch/>
        </p:blipFill>
        <p:spPr>
          <a:xfrm>
            <a:off x="3059280" y="476280"/>
            <a:ext cx="2447640" cy="2448000"/>
          </a:xfrm>
          <a:prstGeom prst="rect">
            <a:avLst/>
          </a:prstGeom>
          <a:ln w="0">
            <a:noFill/>
          </a:ln>
        </p:spPr>
      </p:pic>
      <p:pic>
        <p:nvPicPr>
          <p:cNvPr id="50" name="" descr=""/>
          <p:cNvPicPr/>
          <p:nvPr/>
        </p:nvPicPr>
        <p:blipFill>
          <a:blip r:embed="rId3"/>
          <a:stretch/>
        </p:blipFill>
        <p:spPr>
          <a:xfrm>
            <a:off x="5796000" y="476280"/>
            <a:ext cx="2448000" cy="2448000"/>
          </a:xfrm>
          <a:prstGeom prst="rect">
            <a:avLst/>
          </a:prstGeom>
          <a:ln w="0">
            <a:noFill/>
          </a:ln>
        </p:spPr>
      </p:pic>
      <p:pic>
        <p:nvPicPr>
          <p:cNvPr id="51" name="" descr=""/>
          <p:cNvPicPr/>
          <p:nvPr/>
        </p:nvPicPr>
        <p:blipFill>
          <a:blip r:embed="rId4"/>
          <a:stretch/>
        </p:blipFill>
        <p:spPr>
          <a:xfrm>
            <a:off x="324000" y="3645000"/>
            <a:ext cx="2447640" cy="2448000"/>
          </a:xfrm>
          <a:prstGeom prst="rect">
            <a:avLst/>
          </a:prstGeom>
          <a:ln w="0">
            <a:noFill/>
          </a:ln>
        </p:spPr>
      </p:pic>
      <p:pic>
        <p:nvPicPr>
          <p:cNvPr id="52" name="" descr=""/>
          <p:cNvPicPr/>
          <p:nvPr/>
        </p:nvPicPr>
        <p:blipFill>
          <a:blip r:embed="rId5"/>
          <a:stretch/>
        </p:blipFill>
        <p:spPr>
          <a:xfrm>
            <a:off x="3059280" y="3645000"/>
            <a:ext cx="2447640" cy="2448000"/>
          </a:xfrm>
          <a:prstGeom prst="rect">
            <a:avLst/>
          </a:prstGeom>
          <a:ln w="0">
            <a:noFill/>
          </a:ln>
        </p:spPr>
      </p:pic>
      <p:pic>
        <p:nvPicPr>
          <p:cNvPr id="53" name="" descr=""/>
          <p:cNvPicPr/>
          <p:nvPr/>
        </p:nvPicPr>
        <p:blipFill>
          <a:blip r:embed="rId6"/>
          <a:stretch/>
        </p:blipFill>
        <p:spPr>
          <a:xfrm>
            <a:off x="5796000" y="3645000"/>
            <a:ext cx="2448000" cy="2448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rcRect l="0" t="0" r="6028" b="0"/>
          <a:stretch/>
        </p:blipFill>
        <p:spPr>
          <a:xfrm>
            <a:off x="4067280" y="1197000"/>
            <a:ext cx="4940280" cy="5257800"/>
          </a:xfrm>
          <a:prstGeom prst="rect">
            <a:avLst/>
          </a:prstGeom>
          <a:ln w="0">
            <a:noFill/>
          </a:ln>
        </p:spPr>
      </p:pic>
      <p:pic>
        <p:nvPicPr>
          <p:cNvPr id="55" name="" descr=""/>
          <p:cNvPicPr/>
          <p:nvPr/>
        </p:nvPicPr>
        <p:blipFill>
          <a:blip r:embed="rId2"/>
          <a:stretch/>
        </p:blipFill>
        <p:spPr>
          <a:xfrm>
            <a:off x="179280" y="2212920"/>
            <a:ext cx="3672000" cy="2754360"/>
          </a:xfrm>
          <a:prstGeom prst="rect">
            <a:avLst/>
          </a:prstGeom>
          <a:ln w="0">
            <a:noFill/>
          </a:ln>
        </p:spPr>
      </p:pic>
      <p:sp>
        <p:nvSpPr>
          <p:cNvPr id="56" name=""/>
          <p:cNvSpPr/>
          <p:nvPr/>
        </p:nvSpPr>
        <p:spPr>
          <a:xfrm>
            <a:off x="108000" y="2060640"/>
            <a:ext cx="17287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DEG colonomics seri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835280" y="1700280"/>
            <a:ext cx="1655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DEG validation seri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404720" y="3452760"/>
            <a:ext cx="5191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49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84680" y="115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2773080" y="3452760"/>
            <a:ext cx="63180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106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96720" y="3452760"/>
            <a:ext cx="519120" cy="337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39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6732720" y="2349360"/>
            <a:ext cx="755640" cy="417528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"/>
          <p:cNvSpPr/>
          <p:nvPr/>
        </p:nvSpPr>
        <p:spPr>
          <a:xfrm>
            <a:off x="184680" y="115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653080" y="907920"/>
            <a:ext cx="2581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 HEALTHY MUCOS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973080" y="907920"/>
            <a:ext cx="273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 ADJACENT MUCOS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6" name="" descr=""/>
          <p:cNvPicPr/>
          <p:nvPr/>
        </p:nvPicPr>
        <p:blipFill>
          <a:blip r:embed="rId1"/>
          <a:stretch/>
        </p:blipFill>
        <p:spPr>
          <a:xfrm>
            <a:off x="0" y="1628640"/>
            <a:ext cx="4932360" cy="343404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2"/>
          <a:srcRect l="12158" t="0" r="10708" b="0"/>
          <a:stretch/>
        </p:blipFill>
        <p:spPr>
          <a:xfrm>
            <a:off x="4859280" y="1700280"/>
            <a:ext cx="3888000" cy="39085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"/>
          <p:cNvSpPr/>
          <p:nvPr/>
        </p:nvSpPr>
        <p:spPr>
          <a:xfrm>
            <a:off x="184680" y="115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" descr=""/>
          <p:cNvPicPr/>
          <p:nvPr/>
        </p:nvPicPr>
        <p:blipFill>
          <a:blip r:embed="rId1"/>
          <a:srcRect l="789" t="29029" r="72431" b="58689"/>
          <a:stretch/>
        </p:blipFill>
        <p:spPr>
          <a:xfrm>
            <a:off x="4716360" y="1773360"/>
            <a:ext cx="4319640" cy="1114200"/>
          </a:xfrm>
          <a:prstGeom prst="rect">
            <a:avLst/>
          </a:prstGeom>
          <a:ln w="0">
            <a:noFill/>
          </a:ln>
        </p:spPr>
      </p:pic>
      <p:sp>
        <p:nvSpPr>
          <p:cNvPr id="70" name=""/>
          <p:cNvSpPr/>
          <p:nvPr/>
        </p:nvSpPr>
        <p:spPr>
          <a:xfrm>
            <a:off x="88920" y="1039680"/>
            <a:ext cx="8947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Arial"/>
              </a:rPr>
              <a:t>Enrichment plot: </a:t>
            </a:r>
            <a:r>
              <a:rPr b="0" lang="es-ES" sz="1400" spc="-1" strike="noStrike">
                <a:solidFill>
                  <a:srgbClr val="000000"/>
                </a:solidFill>
                <a:latin typeface="Arial"/>
              </a:rPr>
              <a:t>Genes with promoter regions [-2kb,2kb] around transcription start site containing the motif TGACTCANNSKN which matches annotation for JUN: jun oncoge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1" name="" descr=""/>
          <p:cNvPicPr/>
          <p:nvPr/>
        </p:nvPicPr>
        <p:blipFill>
          <a:blip r:embed="rId2"/>
          <a:srcRect l="0" t="3636" r="0" b="0"/>
          <a:stretch/>
        </p:blipFill>
        <p:spPr>
          <a:xfrm>
            <a:off x="198360" y="1700280"/>
            <a:ext cx="4464000" cy="43005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" descr=""/>
          <p:cNvPicPr/>
          <p:nvPr/>
        </p:nvPicPr>
        <p:blipFill>
          <a:blip r:embed="rId1"/>
          <a:stretch/>
        </p:blipFill>
        <p:spPr>
          <a:xfrm>
            <a:off x="34920" y="47520"/>
            <a:ext cx="8943840" cy="6799320"/>
          </a:xfrm>
          <a:prstGeom prst="rect">
            <a:avLst/>
          </a:prstGeom>
          <a:ln w="0">
            <a:noFill/>
          </a:ln>
        </p:spPr>
      </p:pic>
      <p:grpSp>
        <p:nvGrpSpPr>
          <p:cNvPr id="73" name=""/>
          <p:cNvGrpSpPr/>
          <p:nvPr/>
        </p:nvGrpSpPr>
        <p:grpSpPr>
          <a:xfrm>
            <a:off x="1132560" y="692280"/>
            <a:ext cx="6924600" cy="5430960"/>
            <a:chOff x="1132560" y="692280"/>
            <a:chExt cx="6924600" cy="5430960"/>
          </a:xfrm>
        </p:grpSpPr>
        <p:sp>
          <p:nvSpPr>
            <p:cNvPr id="74" name=""/>
            <p:cNvSpPr/>
            <p:nvPr/>
          </p:nvSpPr>
          <p:spPr>
            <a:xfrm>
              <a:off x="6229800" y="5440320"/>
              <a:ext cx="5176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NRP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7454160" y="2492280"/>
              <a:ext cx="6030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AC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5468400" y="841320"/>
              <a:ext cx="53892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E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4372200" y="1197000"/>
              <a:ext cx="68832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GFBR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4085280" y="692280"/>
              <a:ext cx="50364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511440" y="1052640"/>
              <a:ext cx="55404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TGA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356920" y="1370160"/>
              <a:ext cx="6030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NTN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043800" y="2041560"/>
              <a:ext cx="5176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DC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5937480" y="3030480"/>
              <a:ext cx="61056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GT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453280" y="3500280"/>
              <a:ext cx="5328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TSG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5726880" y="4365720"/>
              <a:ext cx="51912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DL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588200" y="4005360"/>
              <a:ext cx="4626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LIF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014000" y="4653000"/>
              <a:ext cx="6030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ALD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444920" y="2449440"/>
              <a:ext cx="55404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TGA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301280" y="3006720"/>
              <a:ext cx="50364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D3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856160" y="5103720"/>
              <a:ext cx="5328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ROR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707840" y="2637000"/>
              <a:ext cx="5968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GFR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132560" y="3645000"/>
              <a:ext cx="65916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IGDCC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279600" y="2584440"/>
              <a:ext cx="7066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ECAM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2645640" y="3094200"/>
              <a:ext cx="6012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PHA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271240" y="5877000"/>
              <a:ext cx="5464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AF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488400" y="4076640"/>
              <a:ext cx="4338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JU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486880" y="3645000"/>
              <a:ext cx="52524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JUN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957680" y="4508640"/>
              <a:ext cx="49788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TF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052720" y="4005360"/>
              <a:ext cx="53280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OS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2657160" y="4292640"/>
              <a:ext cx="441360" cy="2462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O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0" name=""/>
          <p:cNvSpPr/>
          <p:nvPr/>
        </p:nvSpPr>
        <p:spPr>
          <a:xfrm>
            <a:off x="184680" y="115920"/>
            <a:ext cx="2487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600" spc="-1" strike="noStrike">
                <a:solidFill>
                  <a:srgbClr val="000000"/>
                </a:solidFill>
                <a:latin typeface="Arial"/>
              </a:rPr>
              <a:t>Supplementary Figure 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31T15:29:43Z</dcterms:created>
  <dc:creator>h501xrsp</dc:creator>
  <dc:description/>
  <dc:language>en-US</dc:language>
  <cp:lastModifiedBy>h501xrsp</cp:lastModifiedBy>
  <dcterms:modified xsi:type="dcterms:W3CDTF">2014-01-30T13:36:39Z</dcterms:modified>
  <cp:revision>73</cp:revision>
  <dc:subject/>
  <dc:title>Diapositiva 1</dc:title>
</cp:coreProperties>
</file>